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1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59" r:id="rId4"/>
  </p:sldMasterIdLst>
  <p:notesMasterIdLst>
    <p:notesMasterId r:id="rId5"/>
  </p:notesMasterIdLst>
  <p:sldIdLst>
    <p:sldId id="256" r:id="rId6"/>
  </p:sldIdLst>
  <p:sldSz cy="5143500" cx="9144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1620">
          <p15:clr>
            <a:srgbClr val="747775"/>
          </p15:clr>
        </p15:guide>
        <p15:guide id="2" pos="2880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1620" orient="horz"/>
        <p:guide pos="2880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2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:notes"/>
          <p:cNvSpPr/>
          <p:nvPr>
            <p:ph idx="2" type="sldImg"/>
          </p:nvPr>
        </p:nvSpPr>
        <p:spPr>
          <a:xfrm>
            <a:off x="381300" y="685800"/>
            <a:ext cx="609607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p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311708" y="744575"/>
            <a:ext cx="8520600" cy="20526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311700" y="2834125"/>
            <a:ext cx="8520600" cy="7926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311700" y="1106125"/>
            <a:ext cx="8520600" cy="19635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311700" y="3152225"/>
            <a:ext cx="8520600" cy="1300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311700" y="2150850"/>
            <a:ext cx="8520600" cy="841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3117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4832400" y="1152475"/>
            <a:ext cx="3999900" cy="3416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311700" y="555600"/>
            <a:ext cx="2808000" cy="7557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311700" y="1389600"/>
            <a:ext cx="2808000" cy="31794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90250" y="450150"/>
            <a:ext cx="6367800" cy="40908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4572000" y="-125"/>
            <a:ext cx="4572000" cy="51435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65500" y="1233175"/>
            <a:ext cx="4045200" cy="14823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65500" y="2803075"/>
            <a:ext cx="4045200" cy="1235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939500" y="724075"/>
            <a:ext cx="3837000" cy="369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311700" y="4230575"/>
            <a:ext cx="5998800" cy="605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2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311700" y="445025"/>
            <a:ext cx="8520600" cy="572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311700" y="1152475"/>
            <a:ext cx="8520600" cy="34164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indent="-317500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indent="-317500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indent="-317500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indent="-317500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indent="-317500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indent="-317500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indent="-317500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indent="-317500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8472458" y="4663217"/>
            <a:ext cx="548700" cy="3936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3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13"/>
          <p:cNvSpPr txBox="1"/>
          <p:nvPr/>
        </p:nvSpPr>
        <p:spPr>
          <a:xfrm>
            <a:off x="330900" y="4585400"/>
            <a:ext cx="8482200" cy="280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200">
                <a:solidFill>
                  <a:schemeClr val="dk2"/>
                </a:solidFill>
              </a:rPr>
              <a:t>Supplementary Figure </a:t>
            </a:r>
            <a:r>
              <a:rPr b="1" lang="en" sz="1200">
                <a:solidFill>
                  <a:schemeClr val="dk2"/>
                </a:solidFill>
              </a:rPr>
              <a:t>2: Gene recall curve of identified biomarkers in top 5,000 features concerning reference biomarker of cell types by scaLR and CellTypist.</a:t>
            </a:r>
            <a:r>
              <a:rPr b="1" lang="en" sz="1200">
                <a:solidFill>
                  <a:schemeClr val="dk2"/>
                </a:solidFill>
              </a:rPr>
              <a:t> </a:t>
            </a:r>
            <a:endParaRPr b="1" sz="1200">
              <a:solidFill>
                <a:schemeClr val="dk2"/>
              </a:solidFill>
            </a:endParaRPr>
          </a:p>
        </p:txBody>
      </p:sp>
      <p:pic>
        <p:nvPicPr>
          <p:cNvPr id="55" name="Google Shape;55;p1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100475" y="0"/>
            <a:ext cx="6910049" cy="464605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